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A426EB-9D94-452B-BF76-E407B59CAD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8E36F-3A59-4FA0-A953-7BE70ABC20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4369D-7437-450B-B6A7-164EB00A8C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AF039-7DE7-4CE1-9C2E-E3CC873035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BE551-B312-42D1-9343-9227196CDC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9DA38-97CF-4D2E-84C2-EFC674AEE8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CDDDC-38D7-411E-9C05-B1A06401CA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1550F-5259-4950-B518-C9C3D76710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55840-5EE0-43AC-A3C4-754E5B40ED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61E40-67DF-4455-BC22-E77F147717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752F6-271F-4570-BE46-ED7206DE18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F5D10-32CD-4EA3-A150-52E8A5C27E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38BFFB8-3EBC-4E8C-80AA-CE70509C53FD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98A720A-5C66-44B4-BCC3-29307B705CF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7360560" y="631512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9"/>
          <p:cNvGrpSpPr/>
          <p:nvPr/>
        </p:nvGrpSpPr>
        <p:grpSpPr>
          <a:xfrm>
            <a:off x="503280" y="588960"/>
            <a:ext cx="8137440" cy="5649840"/>
            <a:chOff x="503280" y="588960"/>
            <a:chExt cx="8137440" cy="5649840"/>
          </a:xfrm>
        </p:grpSpPr>
        <p:pic>
          <p:nvPicPr>
            <p:cNvPr id="43" name="Picture 2" descr=""/>
            <p:cNvPicPr/>
            <p:nvPr/>
          </p:nvPicPr>
          <p:blipFill>
            <a:blip r:embed="rId1"/>
            <a:stretch/>
          </p:blipFill>
          <p:spPr>
            <a:xfrm>
              <a:off x="3093480" y="633240"/>
              <a:ext cx="5547240" cy="530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10"/>
            <p:cNvSpPr/>
            <p:nvPr/>
          </p:nvSpPr>
          <p:spPr>
            <a:xfrm rot="17812800">
              <a:off x="7170480" y="3313800"/>
              <a:ext cx="185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Hematopoietic syste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12"/>
            <p:cNvSpPr/>
            <p:nvPr/>
          </p:nvSpPr>
          <p:spPr>
            <a:xfrm>
              <a:off x="5190120" y="588960"/>
              <a:ext cx="1847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Nervous syste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19"/>
            <p:cNvSpPr/>
            <p:nvPr/>
          </p:nvSpPr>
          <p:spPr>
            <a:xfrm>
              <a:off x="5751720" y="984960"/>
              <a:ext cx="1847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Muscle + hear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27"/>
            <p:cNvSpPr/>
            <p:nvPr/>
          </p:nvSpPr>
          <p:spPr>
            <a:xfrm>
              <a:off x="5337360" y="5104800"/>
              <a:ext cx="82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Cell li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28"/>
            <p:cNvSpPr/>
            <p:nvPr/>
          </p:nvSpPr>
          <p:spPr>
            <a:xfrm>
              <a:off x="6522480" y="1525680"/>
              <a:ext cx="514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Liv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34"/>
            <p:cNvSpPr/>
            <p:nvPr/>
          </p:nvSpPr>
          <p:spPr>
            <a:xfrm rot="16200000">
              <a:off x="2734560" y="2167560"/>
              <a:ext cx="1407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Mammary glan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0" name="Straight Arrow Connector 14"/>
            <p:cNvCxnSpPr>
              <a:stCxn id="49" idx="2"/>
            </p:cNvCxnSpPr>
            <p:nvPr/>
          </p:nvCxnSpPr>
          <p:spPr>
            <a:xfrm>
              <a:off x="3576600" y="2305800"/>
              <a:ext cx="301680" cy="104400"/>
            </a:xfrm>
            <a:prstGeom prst="straightConnector1">
              <a:avLst/>
            </a:prstGeom>
            <a:ln w="25560">
              <a:solidFill>
                <a:srgbClr val="4f81bd"/>
              </a:solidFill>
              <a:miter/>
              <a:tailEnd len="med" type="arrow" w="med"/>
            </a:ln>
          </p:spPr>
        </p:cxnSp>
        <p:pic>
          <p:nvPicPr>
            <p:cNvPr id="51" name="Picture 15" descr=""/>
            <p:cNvPicPr/>
            <p:nvPr/>
          </p:nvPicPr>
          <p:blipFill>
            <a:blip r:embed="rId2"/>
            <a:stretch/>
          </p:blipFill>
          <p:spPr>
            <a:xfrm>
              <a:off x="503280" y="633240"/>
              <a:ext cx="2285280" cy="218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17"/>
            <p:cNvSpPr/>
            <p:nvPr/>
          </p:nvSpPr>
          <p:spPr>
            <a:xfrm>
              <a:off x="5101200" y="5992560"/>
              <a:ext cx="1355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Principal Component 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8"/>
            <p:cNvSpPr/>
            <p:nvPr/>
          </p:nvSpPr>
          <p:spPr>
            <a:xfrm rot="16200000">
              <a:off x="2277000" y="3121200"/>
              <a:ext cx="1355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Principal Component 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54" name="Straight Arrow Connector 20"/>
          <p:cNvCxnSpPr/>
          <p:nvPr/>
        </p:nvCxnSpPr>
        <p:spPr>
          <a:xfrm flipV="1">
            <a:off x="4571640" y="1261440"/>
            <a:ext cx="1593000" cy="34020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5" name="Straight Arrow Connector 22"/>
          <p:cNvCxnSpPr/>
          <p:nvPr/>
        </p:nvCxnSpPr>
        <p:spPr>
          <a:xfrm flipV="1">
            <a:off x="4723920" y="866520"/>
            <a:ext cx="902520" cy="11952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6" name="Straight Arrow Connector 24"/>
          <p:cNvCxnSpPr/>
          <p:nvPr/>
        </p:nvCxnSpPr>
        <p:spPr>
          <a:xfrm flipV="1">
            <a:off x="5428080" y="866160"/>
            <a:ext cx="197640" cy="126756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7" name="Straight Arrow Connector 30"/>
          <p:cNvCxnSpPr/>
          <p:nvPr/>
        </p:nvCxnSpPr>
        <p:spPr>
          <a:xfrm flipH="1">
            <a:off x="5336640" y="1261800"/>
            <a:ext cx="828000" cy="130068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8" name="Straight Arrow Connector 33"/>
          <p:cNvCxnSpPr>
            <a:endCxn id="48" idx="2"/>
          </p:cNvCxnSpPr>
          <p:nvPr/>
        </p:nvCxnSpPr>
        <p:spPr>
          <a:xfrm flipV="1">
            <a:off x="5751360" y="1802160"/>
            <a:ext cx="1028880" cy="101592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3T13:37:02Z</dcterms:created>
  <dc:creator>Holly Bradley</dc:creator>
  <dc:description/>
  <dc:language>en-US</dc:language>
  <cp:lastModifiedBy>Holly Bradley</cp:lastModifiedBy>
  <dcterms:modified xsi:type="dcterms:W3CDTF">2010-12-16T15:02:13Z</dcterms:modified>
  <cp:revision>2</cp:revision>
  <dc:subject/>
  <dc:title>Slide 1</dc:title>
</cp:coreProperties>
</file>